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8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989" autoAdjust="0"/>
    <p:restoredTop sz="85986" autoAdjust="0"/>
  </p:normalViewPr>
  <p:slideViewPr>
    <p:cSldViewPr>
      <p:cViewPr varScale="1">
        <p:scale>
          <a:sx n="70" d="100"/>
          <a:sy n="70" d="100"/>
        </p:scale>
        <p:origin x="-1896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ADE111-F953-42CB-8298-98C6B28AE735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962B18-DEF8-4269-ADF4-F3441CBDB8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8426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</a:t>
            </a:r>
            <a:r>
              <a:rPr kumimoji="1" lang="en-US" altLang="ja-JP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2</a:t>
            </a:r>
            <a:r>
              <a:rPr kumimoji="1" lang="en-US" altLang="ja-JP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OC curves for predicting hospital mortality (</a:t>
            </a:r>
            <a:r>
              <a:rPr kumimoji="1" lang="en-US" altLang="ja-JP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SOFA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[RR 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≥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0])</a:t>
            </a:r>
            <a:endParaRPr kumimoji="1" lang="ja-JP" altLang="ja-JP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962B18-DEF8-4269-ADF4-F3441CBDB8E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15028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871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5928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7717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aseline="0">
                <a:latin typeface="Times New Roman" panose="02020603050405020304" pitchFamily="18" charset="0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2pPr>
            <a:lvl3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3pPr>
            <a:lvl4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4pPr>
            <a:lvl5pPr>
              <a:defRPr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578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356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67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5117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5995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454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1783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9277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1C497-0BCF-4E2B-9339-B7343AA4B3D4}" type="datetimeFigureOut">
              <a:rPr kumimoji="1" lang="ja-JP" altLang="en-US" smtClean="0"/>
              <a:t>2018/7/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15838-A273-444B-A98D-B7109C32DB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750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正方形/長方形 126"/>
          <p:cNvSpPr/>
          <p:nvPr/>
        </p:nvSpPr>
        <p:spPr>
          <a:xfrm>
            <a:off x="811254" y="507302"/>
            <a:ext cx="3429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ja-JP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2" name="グループ化 131"/>
          <p:cNvGrpSpPr/>
          <p:nvPr/>
        </p:nvGrpSpPr>
        <p:grpSpPr>
          <a:xfrm>
            <a:off x="672260" y="6263093"/>
            <a:ext cx="432048" cy="293987"/>
            <a:chOff x="2915816" y="5013176"/>
            <a:chExt cx="576064" cy="307391"/>
          </a:xfrm>
        </p:grpSpPr>
        <p:cxnSp>
          <p:nvCxnSpPr>
            <p:cNvPr id="133" name="直線コネクタ 132"/>
            <p:cNvCxnSpPr/>
            <p:nvPr/>
          </p:nvCxnSpPr>
          <p:spPr>
            <a:xfrm>
              <a:off x="2915816" y="5013176"/>
              <a:ext cx="576064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コネクタ 133"/>
            <p:cNvCxnSpPr/>
            <p:nvPr/>
          </p:nvCxnSpPr>
          <p:spPr>
            <a:xfrm>
              <a:off x="2915816" y="5320567"/>
              <a:ext cx="576064" cy="0"/>
            </a:xfrm>
            <a:prstGeom prst="line">
              <a:avLst/>
            </a:prstGeom>
            <a:ln w="285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7" name="テキスト ボックス 136"/>
          <p:cNvSpPr txBox="1"/>
          <p:nvPr/>
        </p:nvSpPr>
        <p:spPr>
          <a:xfrm>
            <a:off x="1264160" y="6885957"/>
            <a:ext cx="3887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OFA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 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SOFA (RR </a:t>
            </a:r>
            <a:r>
              <a:rPr lang="en-US" altLang="ja-JP" sz="16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≥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) 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28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7" name="表 8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688136"/>
              </p:ext>
            </p:extLst>
          </p:nvPr>
        </p:nvGraphicFramePr>
        <p:xfrm>
          <a:off x="1212970" y="5724308"/>
          <a:ext cx="3989905" cy="1021837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40952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9992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580456">
                  <a:extLst>
                    <a:ext uri="{9D8B030D-6E8A-4147-A177-3AD203B41FA5}">
                      <a16:colId xmlns="" xmlns:a16="http://schemas.microsoft.com/office/drawing/2014/main" val="819028618"/>
                    </a:ext>
                  </a:extLst>
                </a:gridCol>
              </a:tblGrid>
              <a:tr h="329719">
                <a:tc>
                  <a:txBody>
                    <a:bodyPr/>
                    <a:lstStyle/>
                    <a:p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kumimoji="1"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atistic</a:t>
                      </a:r>
                      <a:r>
                        <a:rPr kumimoji="1" lang="ja-JP" altLang="en-US" sz="12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5%CI)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46059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SOFA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9</a:t>
                      </a:r>
                      <a:r>
                        <a:rPr kumimoji="1" lang="ja-JP" alt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en-US" altLang="ja-JP" sz="12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63-0.75)</a:t>
                      </a:r>
                      <a:endParaRPr lang="en-US" altLang="ja-JP" sz="12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46059">
                <a:tc>
                  <a:txBody>
                    <a:bodyPr/>
                    <a:lstStyle/>
                    <a:p>
                      <a:r>
                        <a:rPr kumimoji="1"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SOFA (RR </a:t>
                      </a:r>
                      <a:r>
                        <a:rPr lang="en-US" altLang="ja-JP" sz="1200" dirty="0" smtClean="0">
                          <a:effectLst/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≥</a:t>
                      </a:r>
                      <a:r>
                        <a:rPr kumimoji="1"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)</a:t>
                      </a:r>
                      <a:endParaRPr kumimoji="1" lang="ja-JP" altLang="en-US" sz="12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  <a:endParaRPr lang="en-US" altLang="ja-JP" sz="12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altLang="ja-JP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64-0.79)</a:t>
                      </a:r>
                      <a:endParaRPr lang="en-US" altLang="ja-JP" sz="1200" b="1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</a:tbl>
          </a:graphicData>
        </a:graphic>
      </p:graphicFrame>
      <p:grpSp>
        <p:nvGrpSpPr>
          <p:cNvPr id="86" name="Group 4"/>
          <p:cNvGrpSpPr>
            <a:grpSpLocks noChangeAspect="1"/>
          </p:cNvGrpSpPr>
          <p:nvPr/>
        </p:nvGrpSpPr>
        <p:grpSpPr bwMode="auto">
          <a:xfrm>
            <a:off x="620688" y="970278"/>
            <a:ext cx="4968551" cy="4676878"/>
            <a:chOff x="573" y="-80"/>
            <a:chExt cx="4549" cy="4566"/>
          </a:xfrm>
        </p:grpSpPr>
        <p:sp>
          <p:nvSpPr>
            <p:cNvPr id="88" name="AutoShape 3"/>
            <p:cNvSpPr>
              <a:spLocks noChangeAspect="1" noChangeArrowheads="1" noTextEdit="1"/>
            </p:cNvSpPr>
            <p:nvPr/>
          </p:nvSpPr>
          <p:spPr bwMode="auto">
            <a:xfrm>
              <a:off x="638" y="-80"/>
              <a:ext cx="4484" cy="4480"/>
            </a:xfrm>
            <a:prstGeom prst="rect">
              <a:avLst/>
            </a:prstGeom>
            <a:no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91" name="Rectangle 5"/>
            <p:cNvSpPr>
              <a:spLocks noChangeArrowheads="1"/>
            </p:cNvSpPr>
            <p:nvPr/>
          </p:nvSpPr>
          <p:spPr bwMode="auto">
            <a:xfrm>
              <a:off x="2727" y="4257"/>
              <a:ext cx="959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en-US" altLang="ja-JP" sz="975" dirty="0">
                  <a:solidFill>
                    <a:srgbClr val="000000"/>
                  </a:solidFill>
                </a:rPr>
                <a:t>1-</a:t>
              </a:r>
              <a:r>
                <a:rPr kumimoji="0" lang="ja-JP" altLang="ja-JP" sz="975" dirty="0">
                  <a:solidFill>
                    <a:srgbClr val="000000"/>
                  </a:solidFill>
                </a:rPr>
                <a:t>Specificity</a:t>
              </a:r>
              <a:endParaRPr kumimoji="0" lang="ja-JP" altLang="ja-JP" sz="1350" dirty="0"/>
            </a:p>
          </p:txBody>
        </p:sp>
        <p:sp>
          <p:nvSpPr>
            <p:cNvPr id="92" name="Rectangle 6"/>
            <p:cNvSpPr>
              <a:spLocks noChangeArrowheads="1"/>
            </p:cNvSpPr>
            <p:nvPr/>
          </p:nvSpPr>
          <p:spPr bwMode="auto">
            <a:xfrm rot="16200000">
              <a:off x="252" y="1930"/>
              <a:ext cx="855" cy="2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Sensitivity</a:t>
              </a:r>
              <a:endParaRPr kumimoji="0" lang="ja-JP" altLang="ja-JP" sz="1350" dirty="0"/>
            </a:p>
          </p:txBody>
        </p:sp>
        <p:sp>
          <p:nvSpPr>
            <p:cNvPr id="93" name="Rectangle 7"/>
            <p:cNvSpPr>
              <a:spLocks noChangeArrowheads="1"/>
            </p:cNvSpPr>
            <p:nvPr/>
          </p:nvSpPr>
          <p:spPr bwMode="auto">
            <a:xfrm>
              <a:off x="1158" y="187"/>
              <a:ext cx="3697" cy="3699"/>
            </a:xfrm>
            <a:prstGeom prst="rect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94" name="Line 8"/>
            <p:cNvSpPr>
              <a:spLocks noChangeShapeType="1"/>
            </p:cNvSpPr>
            <p:nvPr/>
          </p:nvSpPr>
          <p:spPr bwMode="auto">
            <a:xfrm flipH="1">
              <a:off x="1299" y="3886"/>
              <a:ext cx="342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95" name="Line 9"/>
            <p:cNvSpPr>
              <a:spLocks noChangeShapeType="1"/>
            </p:cNvSpPr>
            <p:nvPr/>
          </p:nvSpPr>
          <p:spPr bwMode="auto">
            <a:xfrm>
              <a:off x="4722" y="3886"/>
              <a:ext cx="0" cy="6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96" name="Line 10"/>
            <p:cNvSpPr>
              <a:spLocks noChangeShapeType="1"/>
            </p:cNvSpPr>
            <p:nvPr/>
          </p:nvSpPr>
          <p:spPr bwMode="auto">
            <a:xfrm>
              <a:off x="4034" y="3886"/>
              <a:ext cx="0" cy="6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97" name="Line 11"/>
            <p:cNvSpPr>
              <a:spLocks noChangeShapeType="1"/>
            </p:cNvSpPr>
            <p:nvPr/>
          </p:nvSpPr>
          <p:spPr bwMode="auto">
            <a:xfrm>
              <a:off x="3347" y="3886"/>
              <a:ext cx="0" cy="6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98" name="Line 12"/>
            <p:cNvSpPr>
              <a:spLocks noChangeShapeType="1"/>
            </p:cNvSpPr>
            <p:nvPr/>
          </p:nvSpPr>
          <p:spPr bwMode="auto">
            <a:xfrm>
              <a:off x="2667" y="3886"/>
              <a:ext cx="0" cy="6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99" name="Line 13"/>
            <p:cNvSpPr>
              <a:spLocks noChangeShapeType="1"/>
            </p:cNvSpPr>
            <p:nvPr/>
          </p:nvSpPr>
          <p:spPr bwMode="auto">
            <a:xfrm>
              <a:off x="1979" y="3886"/>
              <a:ext cx="0" cy="6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00" name="Line 14"/>
            <p:cNvSpPr>
              <a:spLocks noChangeShapeType="1"/>
            </p:cNvSpPr>
            <p:nvPr/>
          </p:nvSpPr>
          <p:spPr bwMode="auto">
            <a:xfrm>
              <a:off x="1299" y="3886"/>
              <a:ext cx="0" cy="6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01" name="Rectangle 15"/>
            <p:cNvSpPr>
              <a:spLocks noChangeArrowheads="1"/>
            </p:cNvSpPr>
            <p:nvPr/>
          </p:nvSpPr>
          <p:spPr bwMode="auto">
            <a:xfrm>
              <a:off x="1192" y="4026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1.0</a:t>
              </a:r>
              <a:endParaRPr kumimoji="0" lang="ja-JP" altLang="ja-JP" sz="1350"/>
            </a:p>
          </p:txBody>
        </p:sp>
        <p:sp>
          <p:nvSpPr>
            <p:cNvPr id="102" name="Rectangle 16"/>
            <p:cNvSpPr>
              <a:spLocks noChangeArrowheads="1"/>
            </p:cNvSpPr>
            <p:nvPr/>
          </p:nvSpPr>
          <p:spPr bwMode="auto">
            <a:xfrm>
              <a:off x="1872" y="4026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0.8</a:t>
              </a:r>
              <a:endParaRPr kumimoji="0" lang="ja-JP" altLang="ja-JP" sz="1350"/>
            </a:p>
          </p:txBody>
        </p:sp>
        <p:sp>
          <p:nvSpPr>
            <p:cNvPr id="103" name="Rectangle 17"/>
            <p:cNvSpPr>
              <a:spLocks noChangeArrowheads="1"/>
            </p:cNvSpPr>
            <p:nvPr/>
          </p:nvSpPr>
          <p:spPr bwMode="auto">
            <a:xfrm>
              <a:off x="2560" y="4026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 dirty="0">
                  <a:solidFill>
                    <a:srgbClr val="000000"/>
                  </a:solidFill>
                </a:rPr>
                <a:t>0.6</a:t>
              </a:r>
              <a:endParaRPr kumimoji="0" lang="ja-JP" altLang="ja-JP" sz="1350" dirty="0"/>
            </a:p>
          </p:txBody>
        </p:sp>
        <p:sp>
          <p:nvSpPr>
            <p:cNvPr id="104" name="Rectangle 18"/>
            <p:cNvSpPr>
              <a:spLocks noChangeArrowheads="1"/>
            </p:cNvSpPr>
            <p:nvPr/>
          </p:nvSpPr>
          <p:spPr bwMode="auto">
            <a:xfrm>
              <a:off x="3240" y="4026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0.4</a:t>
              </a:r>
              <a:endParaRPr kumimoji="0" lang="ja-JP" altLang="ja-JP" sz="1350"/>
            </a:p>
          </p:txBody>
        </p:sp>
        <p:sp>
          <p:nvSpPr>
            <p:cNvPr id="105" name="Rectangle 19"/>
            <p:cNvSpPr>
              <a:spLocks noChangeArrowheads="1"/>
            </p:cNvSpPr>
            <p:nvPr/>
          </p:nvSpPr>
          <p:spPr bwMode="auto">
            <a:xfrm>
              <a:off x="3927" y="4026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0.2</a:t>
              </a:r>
              <a:endParaRPr kumimoji="0" lang="ja-JP" altLang="ja-JP" sz="1350"/>
            </a:p>
          </p:txBody>
        </p:sp>
        <p:sp>
          <p:nvSpPr>
            <p:cNvPr id="106" name="Rectangle 20"/>
            <p:cNvSpPr>
              <a:spLocks noChangeArrowheads="1"/>
            </p:cNvSpPr>
            <p:nvPr/>
          </p:nvSpPr>
          <p:spPr bwMode="auto">
            <a:xfrm>
              <a:off x="4615" y="4026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0.0</a:t>
              </a:r>
              <a:endParaRPr kumimoji="0" lang="ja-JP" altLang="ja-JP" sz="1350"/>
            </a:p>
          </p:txBody>
        </p:sp>
        <p:sp>
          <p:nvSpPr>
            <p:cNvPr id="107" name="Line 21"/>
            <p:cNvSpPr>
              <a:spLocks noChangeShapeType="1"/>
            </p:cNvSpPr>
            <p:nvPr/>
          </p:nvSpPr>
          <p:spPr bwMode="auto">
            <a:xfrm flipV="1">
              <a:off x="1158" y="321"/>
              <a:ext cx="0" cy="3425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08" name="Line 22"/>
            <p:cNvSpPr>
              <a:spLocks noChangeShapeType="1"/>
            </p:cNvSpPr>
            <p:nvPr/>
          </p:nvSpPr>
          <p:spPr bwMode="auto">
            <a:xfrm flipH="1">
              <a:off x="1098" y="3746"/>
              <a:ext cx="60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09" name="Line 23"/>
            <p:cNvSpPr>
              <a:spLocks noChangeShapeType="1"/>
            </p:cNvSpPr>
            <p:nvPr/>
          </p:nvSpPr>
          <p:spPr bwMode="auto">
            <a:xfrm flipH="1">
              <a:off x="1098" y="3065"/>
              <a:ext cx="60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10" name="Line 24"/>
            <p:cNvSpPr>
              <a:spLocks noChangeShapeType="1"/>
            </p:cNvSpPr>
            <p:nvPr/>
          </p:nvSpPr>
          <p:spPr bwMode="auto">
            <a:xfrm flipH="1">
              <a:off x="1098" y="2377"/>
              <a:ext cx="60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11" name="Line 25"/>
            <p:cNvSpPr>
              <a:spLocks noChangeShapeType="1"/>
            </p:cNvSpPr>
            <p:nvPr/>
          </p:nvSpPr>
          <p:spPr bwMode="auto">
            <a:xfrm flipH="1">
              <a:off x="1098" y="1696"/>
              <a:ext cx="60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12" name="Line 26"/>
            <p:cNvSpPr>
              <a:spLocks noChangeShapeType="1"/>
            </p:cNvSpPr>
            <p:nvPr/>
          </p:nvSpPr>
          <p:spPr bwMode="auto">
            <a:xfrm flipH="1">
              <a:off x="1098" y="1008"/>
              <a:ext cx="60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13" name="Line 27"/>
            <p:cNvSpPr>
              <a:spLocks noChangeShapeType="1"/>
            </p:cNvSpPr>
            <p:nvPr/>
          </p:nvSpPr>
          <p:spPr bwMode="auto">
            <a:xfrm flipH="1">
              <a:off x="1098" y="321"/>
              <a:ext cx="60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14" name="Rectangle 28"/>
            <p:cNvSpPr>
              <a:spLocks noChangeArrowheads="1"/>
            </p:cNvSpPr>
            <p:nvPr/>
          </p:nvSpPr>
          <p:spPr bwMode="auto">
            <a:xfrm>
              <a:off x="818" y="3705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0.0</a:t>
              </a:r>
              <a:endParaRPr kumimoji="0" lang="ja-JP" altLang="ja-JP" sz="1350"/>
            </a:p>
          </p:txBody>
        </p:sp>
        <p:sp>
          <p:nvSpPr>
            <p:cNvPr id="115" name="Rectangle 29"/>
            <p:cNvSpPr>
              <a:spLocks noChangeArrowheads="1"/>
            </p:cNvSpPr>
            <p:nvPr/>
          </p:nvSpPr>
          <p:spPr bwMode="auto">
            <a:xfrm>
              <a:off x="818" y="3018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0.2</a:t>
              </a:r>
              <a:endParaRPr kumimoji="0" lang="ja-JP" altLang="ja-JP" sz="1350"/>
            </a:p>
          </p:txBody>
        </p:sp>
        <p:sp>
          <p:nvSpPr>
            <p:cNvPr id="116" name="Rectangle 30"/>
            <p:cNvSpPr>
              <a:spLocks noChangeArrowheads="1"/>
            </p:cNvSpPr>
            <p:nvPr/>
          </p:nvSpPr>
          <p:spPr bwMode="auto">
            <a:xfrm>
              <a:off x="818" y="2337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0.4</a:t>
              </a:r>
              <a:endParaRPr kumimoji="0" lang="ja-JP" altLang="ja-JP" sz="1350"/>
            </a:p>
          </p:txBody>
        </p:sp>
        <p:sp>
          <p:nvSpPr>
            <p:cNvPr id="117" name="Rectangle 31"/>
            <p:cNvSpPr>
              <a:spLocks noChangeArrowheads="1"/>
            </p:cNvSpPr>
            <p:nvPr/>
          </p:nvSpPr>
          <p:spPr bwMode="auto">
            <a:xfrm>
              <a:off x="818" y="1649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0.6</a:t>
              </a:r>
              <a:endParaRPr kumimoji="0" lang="ja-JP" altLang="ja-JP" sz="1350"/>
            </a:p>
          </p:txBody>
        </p:sp>
        <p:sp>
          <p:nvSpPr>
            <p:cNvPr id="118" name="Rectangle 32"/>
            <p:cNvSpPr>
              <a:spLocks noChangeArrowheads="1"/>
            </p:cNvSpPr>
            <p:nvPr/>
          </p:nvSpPr>
          <p:spPr bwMode="auto">
            <a:xfrm>
              <a:off x="818" y="961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0.8</a:t>
              </a:r>
              <a:endParaRPr kumimoji="0" lang="ja-JP" altLang="ja-JP" sz="1350"/>
            </a:p>
          </p:txBody>
        </p:sp>
        <p:sp>
          <p:nvSpPr>
            <p:cNvPr id="119" name="Rectangle 33"/>
            <p:cNvSpPr>
              <a:spLocks noChangeArrowheads="1"/>
            </p:cNvSpPr>
            <p:nvPr/>
          </p:nvSpPr>
          <p:spPr bwMode="auto">
            <a:xfrm>
              <a:off x="818" y="280"/>
              <a:ext cx="247" cy="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kumimoji="0" lang="ja-JP" altLang="ja-JP" sz="975">
                  <a:solidFill>
                    <a:srgbClr val="000000"/>
                  </a:solidFill>
                </a:rPr>
                <a:t>1.0</a:t>
              </a:r>
              <a:endParaRPr kumimoji="0" lang="ja-JP" altLang="ja-JP" sz="1350"/>
            </a:p>
          </p:txBody>
        </p:sp>
        <p:sp>
          <p:nvSpPr>
            <p:cNvPr id="120" name="Line 34"/>
            <p:cNvSpPr>
              <a:spLocks noChangeShapeType="1"/>
            </p:cNvSpPr>
            <p:nvPr/>
          </p:nvSpPr>
          <p:spPr bwMode="auto">
            <a:xfrm flipV="1">
              <a:off x="1158" y="187"/>
              <a:ext cx="3697" cy="3699"/>
            </a:xfrm>
            <a:prstGeom prst="line">
              <a:avLst/>
            </a:prstGeom>
            <a:noFill/>
            <a:ln w="11113" cap="rnd">
              <a:solidFill>
                <a:srgbClr val="A9A9A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21" name="Freeform 35"/>
            <p:cNvSpPr>
              <a:spLocks/>
            </p:cNvSpPr>
            <p:nvPr/>
          </p:nvSpPr>
          <p:spPr bwMode="auto">
            <a:xfrm>
              <a:off x="1299" y="321"/>
              <a:ext cx="3423" cy="3425"/>
            </a:xfrm>
            <a:custGeom>
              <a:avLst/>
              <a:gdLst>
                <a:gd name="T0" fmla="*/ 513 w 513"/>
                <a:gd name="T1" fmla="*/ 0 h 513"/>
                <a:gd name="T2" fmla="*/ 323 w 513"/>
                <a:gd name="T3" fmla="*/ 71 h 513"/>
                <a:gd name="T4" fmla="*/ 64 w 513"/>
                <a:gd name="T5" fmla="*/ 312 h 513"/>
                <a:gd name="T6" fmla="*/ 7 w 513"/>
                <a:gd name="T7" fmla="*/ 483 h 513"/>
                <a:gd name="T8" fmla="*/ 0 w 513"/>
                <a:gd name="T9" fmla="*/ 513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13" h="513">
                  <a:moveTo>
                    <a:pt x="513" y="0"/>
                  </a:moveTo>
                  <a:lnTo>
                    <a:pt x="323" y="71"/>
                  </a:lnTo>
                  <a:lnTo>
                    <a:pt x="64" y="312"/>
                  </a:lnTo>
                  <a:lnTo>
                    <a:pt x="7" y="483"/>
                  </a:lnTo>
                  <a:lnTo>
                    <a:pt x="0" y="513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122" name="Freeform 36"/>
            <p:cNvSpPr>
              <a:spLocks noEditPoints="1"/>
            </p:cNvSpPr>
            <p:nvPr/>
          </p:nvSpPr>
          <p:spPr bwMode="auto">
            <a:xfrm>
              <a:off x="1299" y="347"/>
              <a:ext cx="3369" cy="3399"/>
            </a:xfrm>
            <a:custGeom>
              <a:avLst/>
              <a:gdLst>
                <a:gd name="T0" fmla="*/ 497 w 505"/>
                <a:gd name="T1" fmla="*/ 3 h 509"/>
                <a:gd name="T2" fmla="*/ 482 w 505"/>
                <a:gd name="T3" fmla="*/ 10 h 509"/>
                <a:gd name="T4" fmla="*/ 466 w 505"/>
                <a:gd name="T5" fmla="*/ 18 h 509"/>
                <a:gd name="T6" fmla="*/ 451 w 505"/>
                <a:gd name="T7" fmla="*/ 25 h 509"/>
                <a:gd name="T8" fmla="*/ 435 w 505"/>
                <a:gd name="T9" fmla="*/ 32 h 509"/>
                <a:gd name="T10" fmla="*/ 419 w 505"/>
                <a:gd name="T11" fmla="*/ 39 h 509"/>
                <a:gd name="T12" fmla="*/ 403 w 505"/>
                <a:gd name="T13" fmla="*/ 47 h 509"/>
                <a:gd name="T14" fmla="*/ 387 w 505"/>
                <a:gd name="T15" fmla="*/ 54 h 509"/>
                <a:gd name="T16" fmla="*/ 371 w 505"/>
                <a:gd name="T17" fmla="*/ 61 h 509"/>
                <a:gd name="T18" fmla="*/ 356 w 505"/>
                <a:gd name="T19" fmla="*/ 68 h 509"/>
                <a:gd name="T20" fmla="*/ 340 w 505"/>
                <a:gd name="T21" fmla="*/ 76 h 509"/>
                <a:gd name="T22" fmla="*/ 324 w 505"/>
                <a:gd name="T23" fmla="*/ 83 h 509"/>
                <a:gd name="T24" fmla="*/ 308 w 505"/>
                <a:gd name="T25" fmla="*/ 90 h 509"/>
                <a:gd name="T26" fmla="*/ 293 w 505"/>
                <a:gd name="T27" fmla="*/ 97 h 509"/>
                <a:gd name="T28" fmla="*/ 277 w 505"/>
                <a:gd name="T29" fmla="*/ 105 h 509"/>
                <a:gd name="T30" fmla="*/ 261 w 505"/>
                <a:gd name="T31" fmla="*/ 112 h 509"/>
                <a:gd name="T32" fmla="*/ 245 w 505"/>
                <a:gd name="T33" fmla="*/ 119 h 509"/>
                <a:gd name="T34" fmla="*/ 229 w 505"/>
                <a:gd name="T35" fmla="*/ 127 h 509"/>
                <a:gd name="T36" fmla="*/ 214 w 505"/>
                <a:gd name="T37" fmla="*/ 134 h 509"/>
                <a:gd name="T38" fmla="*/ 198 w 505"/>
                <a:gd name="T39" fmla="*/ 141 h 509"/>
                <a:gd name="T40" fmla="*/ 182 w 505"/>
                <a:gd name="T41" fmla="*/ 148 h 509"/>
                <a:gd name="T42" fmla="*/ 166 w 505"/>
                <a:gd name="T43" fmla="*/ 156 h 509"/>
                <a:gd name="T44" fmla="*/ 160 w 505"/>
                <a:gd name="T45" fmla="*/ 161 h 509"/>
                <a:gd name="T46" fmla="*/ 151 w 505"/>
                <a:gd name="T47" fmla="*/ 175 h 509"/>
                <a:gd name="T48" fmla="*/ 141 w 505"/>
                <a:gd name="T49" fmla="*/ 189 h 509"/>
                <a:gd name="T50" fmla="*/ 131 w 505"/>
                <a:gd name="T51" fmla="*/ 203 h 509"/>
                <a:gd name="T52" fmla="*/ 122 w 505"/>
                <a:gd name="T53" fmla="*/ 217 h 509"/>
                <a:gd name="T54" fmla="*/ 112 w 505"/>
                <a:gd name="T55" fmla="*/ 231 h 509"/>
                <a:gd name="T56" fmla="*/ 102 w 505"/>
                <a:gd name="T57" fmla="*/ 245 h 509"/>
                <a:gd name="T58" fmla="*/ 93 w 505"/>
                <a:gd name="T59" fmla="*/ 259 h 509"/>
                <a:gd name="T60" fmla="*/ 83 w 505"/>
                <a:gd name="T61" fmla="*/ 273 h 509"/>
                <a:gd name="T62" fmla="*/ 73 w 505"/>
                <a:gd name="T63" fmla="*/ 287 h 509"/>
                <a:gd name="T64" fmla="*/ 63 w 505"/>
                <a:gd name="T65" fmla="*/ 301 h 509"/>
                <a:gd name="T66" fmla="*/ 54 w 505"/>
                <a:gd name="T67" fmla="*/ 315 h 509"/>
                <a:gd name="T68" fmla="*/ 44 w 505"/>
                <a:gd name="T69" fmla="*/ 329 h 509"/>
                <a:gd name="T70" fmla="*/ 34 w 505"/>
                <a:gd name="T71" fmla="*/ 343 h 509"/>
                <a:gd name="T72" fmla="*/ 29 w 505"/>
                <a:gd name="T73" fmla="*/ 358 h 509"/>
                <a:gd name="T74" fmla="*/ 26 w 505"/>
                <a:gd name="T75" fmla="*/ 374 h 509"/>
                <a:gd name="T76" fmla="*/ 23 w 505"/>
                <a:gd name="T77" fmla="*/ 390 h 509"/>
                <a:gd name="T78" fmla="*/ 21 w 505"/>
                <a:gd name="T79" fmla="*/ 406 h 509"/>
                <a:gd name="T80" fmla="*/ 18 w 505"/>
                <a:gd name="T81" fmla="*/ 422 h 509"/>
                <a:gd name="T82" fmla="*/ 15 w 505"/>
                <a:gd name="T83" fmla="*/ 438 h 509"/>
                <a:gd name="T84" fmla="*/ 12 w 505"/>
                <a:gd name="T85" fmla="*/ 454 h 509"/>
                <a:gd name="T86" fmla="*/ 9 w 505"/>
                <a:gd name="T87" fmla="*/ 470 h 509"/>
                <a:gd name="T88" fmla="*/ 6 w 505"/>
                <a:gd name="T89" fmla="*/ 486 h 509"/>
                <a:gd name="T90" fmla="*/ 4 w 505"/>
                <a:gd name="T91" fmla="*/ 499 h 5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505" h="509">
                  <a:moveTo>
                    <a:pt x="497" y="3"/>
                  </a:moveTo>
                  <a:lnTo>
                    <a:pt x="490" y="7"/>
                  </a:lnTo>
                  <a:moveTo>
                    <a:pt x="482" y="10"/>
                  </a:moveTo>
                  <a:lnTo>
                    <a:pt x="474" y="14"/>
                  </a:lnTo>
                  <a:moveTo>
                    <a:pt x="466" y="18"/>
                  </a:moveTo>
                  <a:lnTo>
                    <a:pt x="458" y="21"/>
                  </a:lnTo>
                  <a:moveTo>
                    <a:pt x="451" y="25"/>
                  </a:moveTo>
                  <a:lnTo>
                    <a:pt x="443" y="28"/>
                  </a:lnTo>
                  <a:moveTo>
                    <a:pt x="435" y="32"/>
                  </a:moveTo>
                  <a:lnTo>
                    <a:pt x="427" y="36"/>
                  </a:lnTo>
                  <a:moveTo>
                    <a:pt x="419" y="39"/>
                  </a:moveTo>
                  <a:lnTo>
                    <a:pt x="411" y="43"/>
                  </a:lnTo>
                  <a:moveTo>
                    <a:pt x="403" y="47"/>
                  </a:moveTo>
                  <a:lnTo>
                    <a:pt x="395" y="50"/>
                  </a:lnTo>
                  <a:moveTo>
                    <a:pt x="387" y="54"/>
                  </a:moveTo>
                  <a:lnTo>
                    <a:pt x="379" y="58"/>
                  </a:lnTo>
                  <a:moveTo>
                    <a:pt x="371" y="61"/>
                  </a:moveTo>
                  <a:lnTo>
                    <a:pt x="364" y="65"/>
                  </a:lnTo>
                  <a:moveTo>
                    <a:pt x="356" y="68"/>
                  </a:moveTo>
                  <a:lnTo>
                    <a:pt x="348" y="72"/>
                  </a:lnTo>
                  <a:moveTo>
                    <a:pt x="340" y="76"/>
                  </a:moveTo>
                  <a:lnTo>
                    <a:pt x="332" y="79"/>
                  </a:lnTo>
                  <a:moveTo>
                    <a:pt x="324" y="83"/>
                  </a:moveTo>
                  <a:lnTo>
                    <a:pt x="316" y="87"/>
                  </a:lnTo>
                  <a:moveTo>
                    <a:pt x="308" y="90"/>
                  </a:moveTo>
                  <a:lnTo>
                    <a:pt x="301" y="94"/>
                  </a:lnTo>
                  <a:moveTo>
                    <a:pt x="293" y="97"/>
                  </a:moveTo>
                  <a:lnTo>
                    <a:pt x="285" y="101"/>
                  </a:lnTo>
                  <a:moveTo>
                    <a:pt x="277" y="105"/>
                  </a:moveTo>
                  <a:lnTo>
                    <a:pt x="269" y="108"/>
                  </a:lnTo>
                  <a:moveTo>
                    <a:pt x="261" y="112"/>
                  </a:moveTo>
                  <a:lnTo>
                    <a:pt x="253" y="116"/>
                  </a:lnTo>
                  <a:moveTo>
                    <a:pt x="245" y="119"/>
                  </a:moveTo>
                  <a:lnTo>
                    <a:pt x="237" y="123"/>
                  </a:lnTo>
                  <a:moveTo>
                    <a:pt x="229" y="127"/>
                  </a:moveTo>
                  <a:lnTo>
                    <a:pt x="221" y="130"/>
                  </a:lnTo>
                  <a:moveTo>
                    <a:pt x="214" y="134"/>
                  </a:moveTo>
                  <a:lnTo>
                    <a:pt x="206" y="137"/>
                  </a:lnTo>
                  <a:moveTo>
                    <a:pt x="198" y="141"/>
                  </a:moveTo>
                  <a:lnTo>
                    <a:pt x="190" y="145"/>
                  </a:lnTo>
                  <a:moveTo>
                    <a:pt x="182" y="148"/>
                  </a:moveTo>
                  <a:lnTo>
                    <a:pt x="174" y="152"/>
                  </a:lnTo>
                  <a:moveTo>
                    <a:pt x="166" y="156"/>
                  </a:moveTo>
                  <a:lnTo>
                    <a:pt x="163" y="157"/>
                  </a:lnTo>
                  <a:lnTo>
                    <a:pt x="160" y="161"/>
                  </a:lnTo>
                  <a:moveTo>
                    <a:pt x="155" y="168"/>
                  </a:moveTo>
                  <a:lnTo>
                    <a:pt x="151" y="175"/>
                  </a:lnTo>
                  <a:moveTo>
                    <a:pt x="146" y="182"/>
                  </a:moveTo>
                  <a:lnTo>
                    <a:pt x="141" y="189"/>
                  </a:lnTo>
                  <a:moveTo>
                    <a:pt x="136" y="196"/>
                  </a:moveTo>
                  <a:lnTo>
                    <a:pt x="131" y="203"/>
                  </a:lnTo>
                  <a:moveTo>
                    <a:pt x="126" y="210"/>
                  </a:moveTo>
                  <a:lnTo>
                    <a:pt x="122" y="217"/>
                  </a:lnTo>
                  <a:moveTo>
                    <a:pt x="117" y="224"/>
                  </a:moveTo>
                  <a:lnTo>
                    <a:pt x="112" y="231"/>
                  </a:lnTo>
                  <a:moveTo>
                    <a:pt x="107" y="238"/>
                  </a:moveTo>
                  <a:lnTo>
                    <a:pt x="102" y="245"/>
                  </a:lnTo>
                  <a:moveTo>
                    <a:pt x="97" y="252"/>
                  </a:moveTo>
                  <a:lnTo>
                    <a:pt x="93" y="259"/>
                  </a:lnTo>
                  <a:moveTo>
                    <a:pt x="88" y="266"/>
                  </a:moveTo>
                  <a:lnTo>
                    <a:pt x="83" y="273"/>
                  </a:lnTo>
                  <a:moveTo>
                    <a:pt x="78" y="280"/>
                  </a:moveTo>
                  <a:lnTo>
                    <a:pt x="73" y="287"/>
                  </a:lnTo>
                  <a:moveTo>
                    <a:pt x="68" y="294"/>
                  </a:moveTo>
                  <a:lnTo>
                    <a:pt x="63" y="301"/>
                  </a:lnTo>
                  <a:moveTo>
                    <a:pt x="59" y="308"/>
                  </a:moveTo>
                  <a:lnTo>
                    <a:pt x="54" y="315"/>
                  </a:lnTo>
                  <a:moveTo>
                    <a:pt x="49" y="322"/>
                  </a:moveTo>
                  <a:lnTo>
                    <a:pt x="44" y="329"/>
                  </a:lnTo>
                  <a:moveTo>
                    <a:pt x="39" y="336"/>
                  </a:moveTo>
                  <a:lnTo>
                    <a:pt x="34" y="343"/>
                  </a:lnTo>
                  <a:moveTo>
                    <a:pt x="31" y="350"/>
                  </a:moveTo>
                  <a:lnTo>
                    <a:pt x="29" y="358"/>
                  </a:lnTo>
                  <a:moveTo>
                    <a:pt x="28" y="366"/>
                  </a:moveTo>
                  <a:lnTo>
                    <a:pt x="26" y="374"/>
                  </a:lnTo>
                  <a:moveTo>
                    <a:pt x="25" y="382"/>
                  </a:moveTo>
                  <a:lnTo>
                    <a:pt x="23" y="390"/>
                  </a:lnTo>
                  <a:moveTo>
                    <a:pt x="22" y="398"/>
                  </a:moveTo>
                  <a:lnTo>
                    <a:pt x="21" y="406"/>
                  </a:lnTo>
                  <a:moveTo>
                    <a:pt x="19" y="414"/>
                  </a:moveTo>
                  <a:lnTo>
                    <a:pt x="18" y="422"/>
                  </a:lnTo>
                  <a:moveTo>
                    <a:pt x="16" y="430"/>
                  </a:moveTo>
                  <a:lnTo>
                    <a:pt x="15" y="438"/>
                  </a:lnTo>
                  <a:moveTo>
                    <a:pt x="13" y="446"/>
                  </a:moveTo>
                  <a:lnTo>
                    <a:pt x="12" y="454"/>
                  </a:lnTo>
                  <a:moveTo>
                    <a:pt x="11" y="462"/>
                  </a:moveTo>
                  <a:lnTo>
                    <a:pt x="9" y="470"/>
                  </a:lnTo>
                  <a:moveTo>
                    <a:pt x="8" y="478"/>
                  </a:moveTo>
                  <a:lnTo>
                    <a:pt x="6" y="486"/>
                  </a:lnTo>
                  <a:moveTo>
                    <a:pt x="5" y="494"/>
                  </a:moveTo>
                  <a:lnTo>
                    <a:pt x="4" y="499"/>
                  </a:lnTo>
                  <a:lnTo>
                    <a:pt x="3" y="502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620141" y="7524328"/>
            <a:ext cx="55451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bbreviations: </a:t>
            </a:r>
            <a:r>
              <a:rPr lang="en-US" dirty="0" err="1"/>
              <a:t>qSOFA</a:t>
            </a:r>
            <a:r>
              <a:rPr lang="en-US"/>
              <a:t> = quick Sequential (Sepsis-related) Organ Failure Assessme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96701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28</TotalTime>
  <Words>78</Words>
  <Application>Microsoft Office PowerPoint</Application>
  <PresentationFormat>On-screen Show (4:3)</PresentationFormat>
  <Paragraphs>2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時岡　史明</dc:creator>
  <cp:lastModifiedBy>Calumpang, Mario Jade</cp:lastModifiedBy>
  <cp:revision>223</cp:revision>
  <dcterms:created xsi:type="dcterms:W3CDTF">2017-03-22T06:45:40Z</dcterms:created>
  <dcterms:modified xsi:type="dcterms:W3CDTF">2018-07-09T03:44:49Z</dcterms:modified>
</cp:coreProperties>
</file>